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36E22-8F95-4046-B005-C393AED1C3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A1419-25E1-4A81-96F1-8EC1EFAD31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78655-1A52-4990-A1CF-E82EE914CF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7C20B-D969-4AD0-9DD0-19335D17D0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672E56-3C48-456D-B1F2-C18DB9ACD9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32869-6E53-4099-9277-5589856A0A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8A745-D325-45AA-8203-F7EFCE9C26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2A976-C343-433D-8A39-B343823E6C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0C4FD6-23CF-4EDB-9C91-E1CCC0EE44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53FFF-D964-4929-B8DD-2C191894BB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AAF07-B568-415F-B8C9-2DFE1D3962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7FF07-E8D2-416C-9142-B38425E3C9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414443-F5E9-4A2F-9D6E-4AE21710CCD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8120" y="40176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89000" y="179280"/>
            <a:ext cx="5832360" cy="149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800" spc="-1" strike="noStrike">
                <a:solidFill>
                  <a:srgbClr val="000000"/>
                </a:solidFill>
                <a:latin typeface="Times New Roman"/>
              </a:rPr>
              <a:t>Data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Times New Roman"/>
              </a:rPr>
              <a:t>Raw data from MassArray analysis of CpG IV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Methylation rate of each CpG units are shown as the mean value of triplicate independent analys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C: healthy control, D: Patients with major depression, NA: not availab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0" y="1835280"/>
          <a:ext cx="6858000" cy="70578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835280"/>
                    <a:ext cx="6858000" cy="7057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0" y="755640"/>
          <a:ext cx="6858000" cy="70581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755640"/>
                    <a:ext cx="6858000" cy="7058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25T08:44:50Z</dcterms:created>
  <dc:creator>Owner</dc:creator>
  <dc:description/>
  <dc:language>en-US</dc:language>
  <cp:lastModifiedBy>Owner</cp:lastModifiedBy>
  <dcterms:modified xsi:type="dcterms:W3CDTF">2011-08-05T09:26:05Z</dcterms:modified>
  <cp:revision>6</cp:revision>
  <dc:subject/>
  <dc:title>スライド 1</dc:title>
</cp:coreProperties>
</file>